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6" r:id="rId2"/>
  </p:sldIdLst>
  <p:sldSz cx="6858000" cy="9144000" type="screen4x3"/>
  <p:notesSz cx="7053263" cy="93091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3127">
          <p15:clr>
            <a:srgbClr val="A4A3A4"/>
          </p15:clr>
        </p15:guide>
        <p15:guide id="2" pos="2141">
          <p15:clr>
            <a:srgbClr val="A4A3A4"/>
          </p15:clr>
        </p15:guide>
        <p15:guide id="3" orient="horz" pos="2932">
          <p15:clr>
            <a:srgbClr val="A4A3A4"/>
          </p15:clr>
        </p15:guide>
        <p15:guide id="4" pos="22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B8F8C"/>
    <a:srgbClr val="C00000"/>
    <a:srgbClr val="595959"/>
    <a:srgbClr val="BFBFBF"/>
    <a:srgbClr val="A6A6A6"/>
    <a:srgbClr val="FF80FF"/>
    <a:srgbClr val="008080"/>
    <a:srgbClr val="FF00FF"/>
    <a:srgbClr val="FF99FF"/>
    <a:srgbClr val="1F49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85" autoAdjust="0"/>
    <p:restoredTop sz="96444" autoAdjust="0"/>
  </p:normalViewPr>
  <p:slideViewPr>
    <p:cSldViewPr>
      <p:cViewPr>
        <p:scale>
          <a:sx n="140" d="100"/>
          <a:sy n="140" d="100"/>
        </p:scale>
        <p:origin x="-1068" y="258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7" d="100"/>
          <a:sy n="57" d="100"/>
        </p:scale>
        <p:origin x="-1836" y="-102"/>
      </p:cViewPr>
      <p:guideLst>
        <p:guide orient="horz" pos="3127"/>
        <p:guide orient="horz" pos="2932"/>
        <p:guide pos="2141"/>
        <p:guide pos="222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Office_Excel_2007_Workbook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K$30:$L$30</c:f>
                <c:numCache>
                  <c:formatCode>General</c:formatCode>
                  <c:ptCount val="2"/>
                  <c:pt idx="0">
                    <c:v>1.3</c:v>
                  </c:pt>
                  <c:pt idx="1">
                    <c:v>1.2</c:v>
                  </c:pt>
                </c:numCache>
              </c:numRef>
            </c:plus>
            <c:minus>
              <c:numRef>
                <c:f>Sheet1!$K$30:$L$30</c:f>
                <c:numCache>
                  <c:formatCode>General</c:formatCode>
                  <c:ptCount val="2"/>
                  <c:pt idx="0">
                    <c:v>1.3</c:v>
                  </c:pt>
                  <c:pt idx="1">
                    <c:v>1.2</c:v>
                  </c:pt>
                </c:numCache>
              </c:numRef>
            </c:minus>
          </c:errBars>
          <c:val>
            <c:numRef>
              <c:f>Sheet1!$I$30:$J$30</c:f>
              <c:numCache>
                <c:formatCode>General</c:formatCode>
                <c:ptCount val="2"/>
                <c:pt idx="0">
                  <c:v>87</c:v>
                </c:pt>
                <c:pt idx="1">
                  <c:v>96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4CD-4B0D-876F-A09ADBBE1F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005056"/>
        <c:axId val="195015040"/>
      </c:barChart>
      <c:catAx>
        <c:axId val="19500505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195015040"/>
        <c:crosses val="autoZero"/>
        <c:auto val="1"/>
        <c:lblAlgn val="ctr"/>
        <c:lblOffset val="100"/>
        <c:noMultiLvlLbl val="0"/>
      </c:catAx>
      <c:valAx>
        <c:axId val="195015040"/>
        <c:scaling>
          <c:orientation val="minMax"/>
          <c:max val="100"/>
          <c:min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ysClr val="windowText" lastClr="000000"/>
                </a:solidFill>
              </a:defRPr>
            </a:pPr>
            <a:endParaRPr lang="en-US"/>
          </a:p>
        </c:txPr>
        <c:crossAx val="19500505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994434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fld id="{2B6084A1-B5D3-41CC-8842-B203588BB8DC}" type="datetimeFigureOut">
              <a:rPr lang="zh-CN" altLang="en-US"/>
              <a:pPr>
                <a:defRPr/>
              </a:pPr>
              <a:t>2017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841635"/>
            <a:ext cx="3057183" cy="4659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994434" y="8841635"/>
            <a:ext cx="3057183" cy="46597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51560D2-1575-4451-815A-3D53F6C15E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2409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94434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17738" y="698500"/>
            <a:ext cx="2617787" cy="34909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4998" y="4421562"/>
            <a:ext cx="5643269" cy="418931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94434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F4925BD-C869-4B4D-B382-3582379F0EB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1927848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E5566B-05BE-44D1-B7E3-38E4CAA8618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9148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94149D-BDDA-4201-82E0-6FAE2A0FCC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325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619D9B-4276-4B9A-9425-760F73F389B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33257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3634D4-5F5E-4BBF-BF78-479822397B4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433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4C6102-D778-408A-872C-525A63A16FF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110060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FAB47-8FA7-4970-97D9-EEBB97BF94D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7900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F473D-3E0B-4E6B-904D-3CCA00EC80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7921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918365-67D0-43B3-83F6-862B95B3C8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8384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5E5345-E42E-4451-A9A5-3916BA95077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13687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2BD010-3833-4D87-9485-E5CCF1A16B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1078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A60578-8205-4F43-9D6A-5BDF60271DE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60521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3629FE0-81A7-43E7-B5D6-6F796DB2B3F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chart" Target="../charts/chart1.xml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3" name="Picture 9" descr="J:\Manuscripts\Manuscript for submission to Plant Physiology\new data\sinapic acid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3987413"/>
            <a:ext cx="2286000" cy="1727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9207713"/>
              </p:ext>
            </p:extLst>
          </p:nvPr>
        </p:nvGraphicFramePr>
        <p:xfrm>
          <a:off x="3352800" y="2050475"/>
          <a:ext cx="2286000" cy="1646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r:id="rId4" imgW="2768040" imgH="1993320" progId="">
                  <p:embed/>
                </p:oleObj>
              </mc:Choice>
              <mc:Fallback>
                <p:oleObj r:id="rId4" imgW="2768040" imgH="1993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52800" y="2050475"/>
                        <a:ext cx="2286000" cy="1646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4671354"/>
              </p:ext>
            </p:extLst>
          </p:nvPr>
        </p:nvGraphicFramePr>
        <p:xfrm>
          <a:off x="1280630" y="1981200"/>
          <a:ext cx="1828800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" name="TextBox 2"/>
          <p:cNvSpPr txBox="1">
            <a:spLocks noChangeArrowheads="1"/>
          </p:cNvSpPr>
          <p:nvPr/>
        </p:nvSpPr>
        <p:spPr bwMode="auto">
          <a:xfrm rot="16200000">
            <a:off x="295519" y="2736812"/>
            <a:ext cx="178822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/>
              <a:t>Germination rate (%)</a:t>
            </a:r>
            <a:endParaRPr lang="zh-CN" alt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675407" y="3854537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09512" y="3850399"/>
            <a:ext cx="473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</a:t>
            </a:r>
            <a:r>
              <a:rPr lang="en-US" sz="1200" baseline="-25000" dirty="0"/>
              <a:t>2</a:t>
            </a:r>
            <a:r>
              <a:rPr lang="en-US" sz="1200" dirty="0"/>
              <a:t>O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47107" y="179653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79442" y="181176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69093" y="3630923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ontro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003517" y="5679374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sinapic</a:t>
            </a:r>
            <a:r>
              <a:rPr lang="en-US" sz="1200" dirty="0"/>
              <a:t> acid</a:t>
            </a:r>
          </a:p>
        </p:txBody>
      </p:sp>
      <p:sp>
        <p:nvSpPr>
          <p:cNvPr id="12" name="TextBox 165"/>
          <p:cNvSpPr txBox="1">
            <a:spLocks noChangeArrowheads="1"/>
          </p:cNvSpPr>
          <p:nvPr/>
        </p:nvSpPr>
        <p:spPr bwMode="auto">
          <a:xfrm>
            <a:off x="580468" y="6060199"/>
            <a:ext cx="5537200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1.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promotes seed germination and early seedling growth in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rabidopsis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omparison of germination rates of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rabidopsis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fter exposure to different concentrations of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for 2 d. Fresh seeds were germinated and grown </a:t>
            </a:r>
            <a:r>
              <a:rPr lang="en-US" altLang="zh-CN" sz="800">
                <a:latin typeface="Times New Roman" panose="02020603050405020304" pitchFamily="18" charset="0"/>
                <a:ea typeface="Times New Roman" panose="02020603050405020304" pitchFamily="18" charset="0"/>
              </a:rPr>
              <a:t>on </a:t>
            </a:r>
            <a:r>
              <a:rPr lang="en-US" altLang="zh-CN" sz="8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wet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lter </a:t>
            </a:r>
            <a:r>
              <a:rPr lang="en-US" altLang="zh-CN" sz="8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aper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with 0.5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M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or water alone as a control. Values are means ± SD of three independent experiments. Asterisks indicate significant changes compared with the mock (P &lt; 0.05) calculated using the Student’s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test. </a:t>
            </a:r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hotographs taken 7 d after seed imbibition. Seeds were germinated and grown on water alone, or water with 0.5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M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.</a:t>
            </a:r>
            <a:endParaRPr lang="en-US" altLang="zh-CN" sz="800" dirty="0">
              <a:ea typeface="ヒラギノ角ゴ Pro W3"/>
              <a:cs typeface="ヒラギノ角ゴ Pro W3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853060" y="665572"/>
            <a:ext cx="8210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Fig. S1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208942212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81</TotalTime>
  <Words>125</Words>
  <Application>Microsoft Office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yun</dc:creator>
  <cp:lastModifiedBy>YC</cp:lastModifiedBy>
  <cp:revision>1037</cp:revision>
  <cp:lastPrinted>2016-05-25T03:23:58Z</cp:lastPrinted>
  <dcterms:created xsi:type="dcterms:W3CDTF">1601-01-01T00:00:00Z</dcterms:created>
  <dcterms:modified xsi:type="dcterms:W3CDTF">2017-05-11T17:30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